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4358B-419B-4A72-ABEA-9FA7E091D2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81DA6F-1BA9-45AC-A73F-C00F435A40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10AB7-C0C8-4533-B675-176DE359E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0C6BBA-981B-40BD-A1E5-081C4FB07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606E96-0BDA-4382-B661-365382399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529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22B57-3908-40C8-9AB0-5BF2234F13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74BA89-CE54-4A99-A6E3-8A424DDB12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EA3F7C-A0C9-444F-BE13-8316AB16C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B1EE91-D683-4E38-90C9-4C1A58814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10D5A-B4B2-4E9E-9CFB-EDC7B95E0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637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42BF07-46E9-4CBE-87A2-CA1378F513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4D4B74-1ECF-44B0-B37A-4613BECAB9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5EA60-2AD9-4EF3-BE0E-D01594EBE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C9E2AB-0813-4568-9F7C-96E9B1B29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FB88B3-C7B1-4F50-93BB-0860FA2A5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411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9D9795-51A3-47A9-A8F2-FA9C7FC6D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3838B0-0CD4-44A9-8CAB-2743132F52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8E1240-DAD5-45E5-9C39-59397AB43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674CF1-7863-42E5-A416-04AEA8F90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1D50A4-1618-44A8-BFA0-FA1601AA8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941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CCEA58-1816-4FAF-8A34-9852417E5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036623-61B1-439A-B18D-6A50F4FAF3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E63015-4C0C-4922-BC82-B794D8799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53AF74-BEF4-427F-8077-D2A9B38FF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8C9E6-6EB4-4C4A-B681-08B43A9E6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903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193D47-B4CB-4208-89A3-9EB220E6C9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D59DFF-580B-4ECF-8D78-47985B5CB7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D5F01A-CAAE-4006-B60B-FC96C28098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EE387-AED8-45C9-9B1D-A89849B42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398C00-4D8C-4B60-8FCF-BA6870656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56A34F-9FE5-4195-8394-0BBFCE3C4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976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5E5B9-38C4-4A22-BBDE-27BF9F733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00B4AE-BC4C-404B-B8CC-61898CC55F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7ED5CF-ED55-4260-BE7A-59FBBA2ADD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C53D04-ED6A-497D-B721-84C674D1E8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7B18DB-60A9-494E-9C06-DF68C0705A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9AB34B-3A6C-4F83-9B52-BF8451153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ED9FF2-BDE1-4A9D-BF64-EED8114D9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4884EC-6D64-48E3-BEED-3EA3082B4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97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AC06C-A07B-4314-8F6D-6755FF8B5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EB4E4A-E50D-4BDA-BC5E-85344D3F3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DFAB7D-E3E5-41E3-A27E-A146000FE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3D88E6-822C-42D6-BBD6-F09598106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466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D059CB-7FC2-487F-A64B-9AE203AB7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44C99E-71CF-453D-A7B5-698F2F303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FC58DC-5BA4-4800-9B0C-78DD7D8F4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300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1D7944-0EA0-4B9A-BFB1-9FDF0ECD4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971B99-DC85-454E-A28C-9E52858F2E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BFEFEF-E0E8-4C50-A52F-5B7A2D6421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B1978A-BB9F-407C-95C6-C0CA3236D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0060F7-F14C-40D1-BD76-FF5F3FBBC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98EDA9-AA99-47FD-B3D8-86AA28DC4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383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28305A-5BD0-4E70-BED5-78120E33A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F5295E-54F4-477F-8B3C-FF806D4B03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A5504C-11FA-41F9-BB35-37BAC770D8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62891B-E329-4123-90C8-8CBEA506F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1852DB-47E9-4D56-9C01-6CA16B939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8E2C2F-DB69-4F8B-A764-2E45CCC3B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24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59CA1D-4044-4025-B4AD-FCEAD6F97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FBB21A-22EB-484A-AD13-8236464FDA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CC262-5A1A-490C-B80A-878DD8E421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DC1E8-B7F0-424E-BC50-2FED6FE4DE0F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D6A256-7F91-41B0-BFFA-787C443FE1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5CCFB5-31DE-474F-981D-7B0444019B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75C2A-C755-4126-8CA0-AAFF1FB74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076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524000" y="1"/>
          <a:ext cx="8900932" cy="602251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64717">
                  <a:extLst>
                    <a:ext uri="{9D8B030D-6E8A-4147-A177-3AD203B41FA5}">
                      <a16:colId xmlns:a16="http://schemas.microsoft.com/office/drawing/2014/main" val="3020974570"/>
                    </a:ext>
                  </a:extLst>
                </a:gridCol>
                <a:gridCol w="1948856">
                  <a:extLst>
                    <a:ext uri="{9D8B030D-6E8A-4147-A177-3AD203B41FA5}">
                      <a16:colId xmlns:a16="http://schemas.microsoft.com/office/drawing/2014/main" val="3078550569"/>
                    </a:ext>
                  </a:extLst>
                </a:gridCol>
                <a:gridCol w="2032731">
                  <a:extLst>
                    <a:ext uri="{9D8B030D-6E8A-4147-A177-3AD203B41FA5}">
                      <a16:colId xmlns:a16="http://schemas.microsoft.com/office/drawing/2014/main" val="205561854"/>
                    </a:ext>
                  </a:extLst>
                </a:gridCol>
                <a:gridCol w="1998194">
                  <a:extLst>
                    <a:ext uri="{9D8B030D-6E8A-4147-A177-3AD203B41FA5}">
                      <a16:colId xmlns:a16="http://schemas.microsoft.com/office/drawing/2014/main" val="214209919"/>
                    </a:ext>
                  </a:extLst>
                </a:gridCol>
                <a:gridCol w="1756434">
                  <a:extLst>
                    <a:ext uri="{9D8B030D-6E8A-4147-A177-3AD203B41FA5}">
                      <a16:colId xmlns:a16="http://schemas.microsoft.com/office/drawing/2014/main" val="1305851498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/>
                      <a:endParaRPr lang="en-US" sz="800" b="1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POD4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POD18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POD35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POD56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58925138"/>
                  </a:ext>
                </a:extLst>
              </a:tr>
              <a:tr h="2229538">
                <a:tc>
                  <a:txBody>
                    <a:bodyPr/>
                    <a:lstStyle/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Infected </a:t>
                      </a:r>
                    </a:p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1e2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8125496"/>
                  </a:ext>
                </a:extLst>
              </a:tr>
              <a:tr h="2345814">
                <a:tc>
                  <a:txBody>
                    <a:bodyPr/>
                    <a:lstStyle/>
                    <a:p>
                      <a:pPr algn="ctr"/>
                      <a:r>
                        <a:rPr lang="en-US" sz="800" i="0" dirty="0">
                          <a:latin typeface="Arial"/>
                          <a:cs typeface="Arial"/>
                        </a:rPr>
                        <a:t>Sterile Control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3384016"/>
                  </a:ext>
                </a:extLst>
              </a:tr>
              <a:tr h="1172843">
                <a:tc gridSpan="5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Supplemental Figure 8. Cortical allograft histology. Hematoxylin and eosin stain. (</a:t>
                      </a:r>
                      <a:r>
                        <a:rPr lang="en-US" sz="800" b="0" i="0" kern="1200" dirty="0" err="1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i</a:t>
                      </a:r>
                      <a:r>
                        <a:rPr lang="en-US" sz="800" b="0" i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)-(iv): Inoculated with 1*10</a:t>
                      </a:r>
                      <a:r>
                        <a:rPr lang="en-US" sz="8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2 </a:t>
                      </a:r>
                      <a:r>
                        <a:rPr lang="en-US" sz="800" b="0" i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CFU S. aureus. (v)-(viii): Sterile control. (</a:t>
                      </a:r>
                      <a:r>
                        <a:rPr lang="en-US" sz="800" b="0" i="0" kern="1200" dirty="0" err="1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i</a:t>
                      </a:r>
                      <a:r>
                        <a:rPr lang="en-US" sz="800" b="0" i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): POD4, 200x and 400x, acute inflammatory cells, no capsule; (ii): POD18, 200x and 400x, thick inflammatory capsule and evidence of neovascularization in cortical bone; (iii): POD35, 200x and 400x, thick inflammatory capsule and evidence of neovascularization in cortical bone; (iv): POD56, 200x, neovascular formation within thick capsule and extensive inflammatory reaction, 400x, bacterial cocci within haversian canal (white inset box in subsequent figure); (v): sterile POD4, 200x and 400x, acute inflammatory cells, no capsule; (vi): sterile POD18, 200x and 400x, thin inflammatory capsule, no evidence of bacteria (vii): sterile POD35, 200 and 400x, thin inflammatory capsule, no evidence of bacteria, and a multinucleated giant cell with resorption pit; (viii): sterile POD56, 200x and 400x, thin inflammatory capsule, no evidence of bacteria. * = bone, + = capsule, white arrow = inflammatory cells, blue arrowhead = cocci bacteria, white inset box = magnification on subsequent figure 8b.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38687849"/>
                  </a:ext>
                </a:extLst>
              </a:tr>
            </a:tbl>
          </a:graphicData>
        </a:graphic>
      </p:graphicFrame>
      <p:pic>
        <p:nvPicPr>
          <p:cNvPr id="13" name="Picture 12">
            <a:extLst>
              <a:ext uri="{FF2B5EF4-FFF2-40B4-BE49-F238E27FC236}">
                <a16:creationId xmlns:a16="http://schemas.microsoft.com/office/drawing/2014/main" id="{EEF75273-F65E-45C7-9763-7A72A91B7C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27669" y="1422280"/>
            <a:ext cx="1320052" cy="103533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r="16044"/>
          <a:stretch/>
        </p:blipFill>
        <p:spPr>
          <a:xfrm>
            <a:off x="4916525" y="381249"/>
            <a:ext cx="1320052" cy="10300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12" r="12771" b="7513"/>
          <a:stretch/>
        </p:blipFill>
        <p:spPr>
          <a:xfrm>
            <a:off x="8932416" y="363276"/>
            <a:ext cx="1320052" cy="102136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7" t="13260" r="12232" b="4727"/>
          <a:stretch/>
        </p:blipFill>
        <p:spPr>
          <a:xfrm>
            <a:off x="7000403" y="3714409"/>
            <a:ext cx="1326347" cy="104403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9923122" y="1177306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839854" y="2234144"/>
            <a:ext cx="640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400x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972872" y="4517218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x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84" b="16515"/>
          <a:stretch/>
        </p:blipFill>
        <p:spPr>
          <a:xfrm>
            <a:off x="4916525" y="1441443"/>
            <a:ext cx="1322003" cy="1033848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4206" y="3729753"/>
            <a:ext cx="1331142" cy="1044032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6195" y="2639204"/>
            <a:ext cx="1323371" cy="103793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0403" y="1426045"/>
            <a:ext cx="1320052" cy="1035335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5470" y="361672"/>
            <a:ext cx="1320052" cy="103533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0403" y="2619922"/>
            <a:ext cx="1326347" cy="1040272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5881676" y="1223577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891868" y="2285764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x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972873" y="1180561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972872" y="2239486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x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927478" y="3456261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943261" y="4545952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72872" y="3428684"/>
            <a:ext cx="527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932416" y="2605559"/>
            <a:ext cx="1307690" cy="105623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32416" y="3724691"/>
            <a:ext cx="1307690" cy="103375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9859099" y="4500522"/>
            <a:ext cx="6372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x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847208" y="3430288"/>
            <a:ext cx="6372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732533" y="2282858"/>
            <a:ext cx="2135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672976" y="2282858"/>
            <a:ext cx="2295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704815" y="2282858"/>
            <a:ext cx="2519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2486" y="2289804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732533" y="461532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664743" y="461419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i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707220" y="462226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ii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8674493" y="4622266"/>
            <a:ext cx="864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iii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85B3E804-3091-428D-B398-1F2236EDF1C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010421" y="1441442"/>
            <a:ext cx="1281582" cy="1005162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0C70A5E8-30F0-4276-A9EE-08DB259DA40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005415" y="378619"/>
            <a:ext cx="1302235" cy="1021361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7E59C758-1048-4430-B0B3-2E949EE41981}"/>
              </a:ext>
            </a:extLst>
          </p:cNvPr>
          <p:cNvSpPr txBox="1"/>
          <p:nvPr/>
        </p:nvSpPr>
        <p:spPr>
          <a:xfrm>
            <a:off x="3944858" y="1192650"/>
            <a:ext cx="843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CA51075-8B3D-46D1-B54D-2A4C32DB43AC}"/>
              </a:ext>
            </a:extLst>
          </p:cNvPr>
          <p:cNvSpPr txBox="1"/>
          <p:nvPr/>
        </p:nvSpPr>
        <p:spPr>
          <a:xfrm>
            <a:off x="3936681" y="2224775"/>
            <a:ext cx="659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x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FC07E034-55DD-47D3-9172-C227DC5DD995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45088" t="22829" r="26666" b="48526"/>
          <a:stretch/>
        </p:blipFill>
        <p:spPr>
          <a:xfrm>
            <a:off x="2982090" y="2619922"/>
            <a:ext cx="1350477" cy="1074168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4EBC27A-A039-4A51-889A-CBE1638A5C4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988247" y="3731314"/>
            <a:ext cx="1348241" cy="1057444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1F723AC7-DB42-4E60-B7F2-8EDD9041C568}"/>
              </a:ext>
            </a:extLst>
          </p:cNvPr>
          <p:cNvSpPr txBox="1"/>
          <p:nvPr/>
        </p:nvSpPr>
        <p:spPr>
          <a:xfrm>
            <a:off x="3936680" y="3463486"/>
            <a:ext cx="9234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x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443D142-C2E4-4B56-8540-1FB0210D3176}"/>
              </a:ext>
            </a:extLst>
          </p:cNvPr>
          <p:cNvSpPr txBox="1"/>
          <p:nvPr/>
        </p:nvSpPr>
        <p:spPr>
          <a:xfrm>
            <a:off x="3966299" y="4515866"/>
            <a:ext cx="1105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x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555A769-567F-4BE9-97E9-93ECFE9E0194}"/>
              </a:ext>
            </a:extLst>
          </p:cNvPr>
          <p:cNvSpPr/>
          <p:nvPr/>
        </p:nvSpPr>
        <p:spPr>
          <a:xfrm>
            <a:off x="9502140" y="1835406"/>
            <a:ext cx="476229" cy="363838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E69A7E5A-2223-4C17-8E39-80F8CAC9BE9E}"/>
              </a:ext>
            </a:extLst>
          </p:cNvPr>
          <p:cNvSpPr/>
          <p:nvPr/>
        </p:nvSpPr>
        <p:spPr>
          <a:xfrm>
            <a:off x="9502140" y="1835406"/>
            <a:ext cx="476229" cy="363838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D3714D7-2973-44C0-A2E5-71B8A61011BB}"/>
              </a:ext>
            </a:extLst>
          </p:cNvPr>
          <p:cNvSpPr txBox="1"/>
          <p:nvPr/>
        </p:nvSpPr>
        <p:spPr>
          <a:xfrm>
            <a:off x="3848238" y="5625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100702B-7753-482D-B7F9-257A680B6481}"/>
              </a:ext>
            </a:extLst>
          </p:cNvPr>
          <p:cNvSpPr txBox="1"/>
          <p:nvPr/>
        </p:nvSpPr>
        <p:spPr>
          <a:xfrm>
            <a:off x="3089345" y="76209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B4A9A02-63D3-4ACF-B33B-5EC3DB0AF3F7}"/>
              </a:ext>
            </a:extLst>
          </p:cNvPr>
          <p:cNvSpPr txBox="1"/>
          <p:nvPr/>
        </p:nvSpPr>
        <p:spPr>
          <a:xfrm>
            <a:off x="5923635" y="6144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12DD21D-27C2-490E-9DF0-4BBAB327B8F8}"/>
              </a:ext>
            </a:extLst>
          </p:cNvPr>
          <p:cNvSpPr txBox="1"/>
          <p:nvPr/>
        </p:nvSpPr>
        <p:spPr>
          <a:xfrm>
            <a:off x="7739079" y="14304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74C3FE0-4BCD-442E-B8FE-FBD33C7F342A}"/>
              </a:ext>
            </a:extLst>
          </p:cNvPr>
          <p:cNvSpPr txBox="1"/>
          <p:nvPr/>
        </p:nvSpPr>
        <p:spPr>
          <a:xfrm>
            <a:off x="9169151" y="15325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85D8C52-2019-4E33-BC96-16B790D3D6A8}"/>
              </a:ext>
            </a:extLst>
          </p:cNvPr>
          <p:cNvSpPr txBox="1"/>
          <p:nvPr/>
        </p:nvSpPr>
        <p:spPr>
          <a:xfrm>
            <a:off x="9462075" y="221094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B3C5834-1EBD-47B3-9C15-4360B00A839B}"/>
              </a:ext>
            </a:extLst>
          </p:cNvPr>
          <p:cNvSpPr txBox="1"/>
          <p:nvPr/>
        </p:nvSpPr>
        <p:spPr>
          <a:xfrm>
            <a:off x="7852871" y="288801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01C4C63-21B3-4A1D-8056-A2644AC08BB5}"/>
              </a:ext>
            </a:extLst>
          </p:cNvPr>
          <p:cNvSpPr txBox="1"/>
          <p:nvPr/>
        </p:nvSpPr>
        <p:spPr>
          <a:xfrm>
            <a:off x="2982089" y="294901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0D6F8F6-1A98-4290-89A1-08FB7F5C5AE3}"/>
              </a:ext>
            </a:extLst>
          </p:cNvPr>
          <p:cNvSpPr txBox="1"/>
          <p:nvPr/>
        </p:nvSpPr>
        <p:spPr>
          <a:xfrm>
            <a:off x="9909914" y="302734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7F82085-083E-4B27-B674-22CCC017985F}"/>
              </a:ext>
            </a:extLst>
          </p:cNvPr>
          <p:cNvSpPr txBox="1"/>
          <p:nvPr/>
        </p:nvSpPr>
        <p:spPr>
          <a:xfrm>
            <a:off x="5051541" y="40348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CBBA4D9-36CE-4C0A-93BD-55D3D3BA34CC}"/>
              </a:ext>
            </a:extLst>
          </p:cNvPr>
          <p:cNvSpPr txBox="1"/>
          <p:nvPr/>
        </p:nvSpPr>
        <p:spPr>
          <a:xfrm>
            <a:off x="7564225" y="446143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21F482-5757-481F-9A49-A9B2C8D7AC57}"/>
              </a:ext>
            </a:extLst>
          </p:cNvPr>
          <p:cNvSpPr txBox="1"/>
          <p:nvPr/>
        </p:nvSpPr>
        <p:spPr>
          <a:xfrm>
            <a:off x="10009258" y="412702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012A04E-299A-4337-A55B-CF79619B94FA}"/>
              </a:ext>
            </a:extLst>
          </p:cNvPr>
          <p:cNvSpPr txBox="1"/>
          <p:nvPr/>
        </p:nvSpPr>
        <p:spPr>
          <a:xfrm>
            <a:off x="5006108" y="50228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A731B23-8700-4211-94CF-C5D2EFF66B5D}"/>
              </a:ext>
            </a:extLst>
          </p:cNvPr>
          <p:cNvSpPr txBox="1"/>
          <p:nvPr/>
        </p:nvSpPr>
        <p:spPr>
          <a:xfrm>
            <a:off x="7325625" y="82821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DE43A9A-AC9C-4D81-8EC5-5A900DC52FAA}"/>
              </a:ext>
            </a:extLst>
          </p:cNvPr>
          <p:cNvSpPr txBox="1"/>
          <p:nvPr/>
        </p:nvSpPr>
        <p:spPr>
          <a:xfrm>
            <a:off x="9092325" y="45888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DF17BD9-96AA-4287-9281-AD39A66DFE33}"/>
              </a:ext>
            </a:extLst>
          </p:cNvPr>
          <p:cNvSpPr txBox="1"/>
          <p:nvPr/>
        </p:nvSpPr>
        <p:spPr>
          <a:xfrm>
            <a:off x="7267794" y="20039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C6B0BD3-8466-4D3D-8C16-EBE661B2FF93}"/>
              </a:ext>
            </a:extLst>
          </p:cNvPr>
          <p:cNvSpPr txBox="1"/>
          <p:nvPr/>
        </p:nvSpPr>
        <p:spPr>
          <a:xfrm>
            <a:off x="5698525" y="40043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8DA9508-4E90-40BD-B419-7A376D902478}"/>
              </a:ext>
            </a:extLst>
          </p:cNvPr>
          <p:cNvSpPr txBox="1"/>
          <p:nvPr/>
        </p:nvSpPr>
        <p:spPr>
          <a:xfrm>
            <a:off x="4960248" y="322621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142F35F-E1D3-4254-B206-F965FB5A832D}"/>
              </a:ext>
            </a:extLst>
          </p:cNvPr>
          <p:cNvSpPr txBox="1"/>
          <p:nvPr/>
        </p:nvSpPr>
        <p:spPr>
          <a:xfrm>
            <a:off x="7459653" y="381873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E64B86A-0C94-487A-A080-29A0EAB014CC}"/>
              </a:ext>
            </a:extLst>
          </p:cNvPr>
          <p:cNvSpPr txBox="1"/>
          <p:nvPr/>
        </p:nvSpPr>
        <p:spPr>
          <a:xfrm>
            <a:off x="9202057" y="410486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2DD7D87-6C9A-47CF-8B0D-BDE6A9D6E09F}"/>
              </a:ext>
            </a:extLst>
          </p:cNvPr>
          <p:cNvSpPr txBox="1"/>
          <p:nvPr/>
        </p:nvSpPr>
        <p:spPr>
          <a:xfrm>
            <a:off x="9242366" y="291455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6" name="Arrow: Right 75">
            <a:extLst>
              <a:ext uri="{FF2B5EF4-FFF2-40B4-BE49-F238E27FC236}">
                <a16:creationId xmlns:a16="http://schemas.microsoft.com/office/drawing/2014/main" id="{EADB7DCF-3F71-4EF0-A53A-5EE68C6C3E43}"/>
              </a:ext>
            </a:extLst>
          </p:cNvPr>
          <p:cNvSpPr/>
          <p:nvPr/>
        </p:nvSpPr>
        <p:spPr>
          <a:xfrm>
            <a:off x="3214178" y="1430439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7" name="Arrow: Right 76">
            <a:extLst>
              <a:ext uri="{FF2B5EF4-FFF2-40B4-BE49-F238E27FC236}">
                <a16:creationId xmlns:a16="http://schemas.microsoft.com/office/drawing/2014/main" id="{1541DC13-FC1F-4F47-A90E-D6FF825C2305}"/>
              </a:ext>
            </a:extLst>
          </p:cNvPr>
          <p:cNvSpPr/>
          <p:nvPr/>
        </p:nvSpPr>
        <p:spPr>
          <a:xfrm>
            <a:off x="5445421" y="2125614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8" name="Arrow: Right 77">
            <a:extLst>
              <a:ext uri="{FF2B5EF4-FFF2-40B4-BE49-F238E27FC236}">
                <a16:creationId xmlns:a16="http://schemas.microsoft.com/office/drawing/2014/main" id="{2B4BFDF6-25AC-47A6-9BDA-B36E0C4660E4}"/>
              </a:ext>
            </a:extLst>
          </p:cNvPr>
          <p:cNvSpPr/>
          <p:nvPr/>
        </p:nvSpPr>
        <p:spPr>
          <a:xfrm>
            <a:off x="7052395" y="599554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9" name="Arrow: Right 78">
            <a:extLst>
              <a:ext uri="{FF2B5EF4-FFF2-40B4-BE49-F238E27FC236}">
                <a16:creationId xmlns:a16="http://schemas.microsoft.com/office/drawing/2014/main" id="{E1C6A124-0F5F-4EDD-8E72-EED62F331AF9}"/>
              </a:ext>
            </a:extLst>
          </p:cNvPr>
          <p:cNvSpPr/>
          <p:nvPr/>
        </p:nvSpPr>
        <p:spPr>
          <a:xfrm>
            <a:off x="7002160" y="1674878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0" name="Arrow: Right 79">
            <a:extLst>
              <a:ext uri="{FF2B5EF4-FFF2-40B4-BE49-F238E27FC236}">
                <a16:creationId xmlns:a16="http://schemas.microsoft.com/office/drawing/2014/main" id="{AD2D00C3-EF8E-4304-B7D7-5EC527073AA3}"/>
              </a:ext>
            </a:extLst>
          </p:cNvPr>
          <p:cNvSpPr/>
          <p:nvPr/>
        </p:nvSpPr>
        <p:spPr>
          <a:xfrm>
            <a:off x="9202057" y="727710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1" name="Arrow: Right 80">
            <a:extLst>
              <a:ext uri="{FF2B5EF4-FFF2-40B4-BE49-F238E27FC236}">
                <a16:creationId xmlns:a16="http://schemas.microsoft.com/office/drawing/2014/main" id="{CF95FE99-DD64-427E-A9B9-7A6CE6755D4B}"/>
              </a:ext>
            </a:extLst>
          </p:cNvPr>
          <p:cNvSpPr/>
          <p:nvPr/>
        </p:nvSpPr>
        <p:spPr>
          <a:xfrm>
            <a:off x="9143479" y="1941724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Isosceles Triangle 81">
            <a:extLst>
              <a:ext uri="{FF2B5EF4-FFF2-40B4-BE49-F238E27FC236}">
                <a16:creationId xmlns:a16="http://schemas.microsoft.com/office/drawing/2014/main" id="{624E9C92-00D7-4AF3-971B-99ECA7936E5D}"/>
              </a:ext>
            </a:extLst>
          </p:cNvPr>
          <p:cNvSpPr/>
          <p:nvPr/>
        </p:nvSpPr>
        <p:spPr>
          <a:xfrm rot="17739085">
            <a:off x="9937941" y="1881461"/>
            <a:ext cx="198008" cy="260764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Arrow: Right 82">
            <a:extLst>
              <a:ext uri="{FF2B5EF4-FFF2-40B4-BE49-F238E27FC236}">
                <a16:creationId xmlns:a16="http://schemas.microsoft.com/office/drawing/2014/main" id="{6D96919F-D9A2-4439-9342-BFDDCB7D03DD}"/>
              </a:ext>
            </a:extLst>
          </p:cNvPr>
          <p:cNvSpPr/>
          <p:nvPr/>
        </p:nvSpPr>
        <p:spPr>
          <a:xfrm>
            <a:off x="3446878" y="4378137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4" name="Arrow: Right 83">
            <a:extLst>
              <a:ext uri="{FF2B5EF4-FFF2-40B4-BE49-F238E27FC236}">
                <a16:creationId xmlns:a16="http://schemas.microsoft.com/office/drawing/2014/main" id="{A0346A94-A5C9-400A-BBB8-F87F83CC344B}"/>
              </a:ext>
            </a:extLst>
          </p:cNvPr>
          <p:cNvSpPr/>
          <p:nvPr/>
        </p:nvSpPr>
        <p:spPr>
          <a:xfrm>
            <a:off x="5396073" y="3377124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5" name="Arrow: Right 84">
            <a:extLst>
              <a:ext uri="{FF2B5EF4-FFF2-40B4-BE49-F238E27FC236}">
                <a16:creationId xmlns:a16="http://schemas.microsoft.com/office/drawing/2014/main" id="{EF61E4AE-8422-45EF-8E99-C93109D76E27}"/>
              </a:ext>
            </a:extLst>
          </p:cNvPr>
          <p:cNvSpPr/>
          <p:nvPr/>
        </p:nvSpPr>
        <p:spPr>
          <a:xfrm>
            <a:off x="5595462" y="3887189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981EC27-68E8-42F3-AA58-BCBC0F27F419}"/>
              </a:ext>
            </a:extLst>
          </p:cNvPr>
          <p:cNvSpPr txBox="1"/>
          <p:nvPr/>
        </p:nvSpPr>
        <p:spPr>
          <a:xfrm>
            <a:off x="7397814" y="295539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87" name="Arrow: Right 86">
            <a:extLst>
              <a:ext uri="{FF2B5EF4-FFF2-40B4-BE49-F238E27FC236}">
                <a16:creationId xmlns:a16="http://schemas.microsoft.com/office/drawing/2014/main" id="{2CFE0D0E-6921-4D67-8128-FDB3284919F2}"/>
              </a:ext>
            </a:extLst>
          </p:cNvPr>
          <p:cNvSpPr/>
          <p:nvPr/>
        </p:nvSpPr>
        <p:spPr>
          <a:xfrm>
            <a:off x="7151429" y="4227687"/>
            <a:ext cx="300082" cy="2422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43716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1" grpId="0"/>
      <p:bldP spid="33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9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4:39Z</dcterms:created>
  <dcterms:modified xsi:type="dcterms:W3CDTF">2020-08-22T04:24:50Z</dcterms:modified>
</cp:coreProperties>
</file>